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E2BF0-D7D1-48E1-BC6C-38CDBB6197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6B4CE5-2EFE-4D2F-9004-2CDBEA311E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7D947-CD00-475B-8A2C-F3BD15EAB4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CA8D0-7813-4E3E-B0CB-0E9E015FA8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CEC5C8-66EE-4579-8F42-F16939CDE4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35DC2-00A5-4B90-A510-F7800F8DEE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B7A25-42E9-4986-9853-90028B5381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470A7-541C-4B2B-A613-BC302D649D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D3294-99A4-4AB6-B3AB-223055514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60F79-D4F0-4C2F-993B-BEAAAC8B63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1F6AE-ECEF-4428-B091-B6804163DB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A31E8-511A-4654-ADFA-D0D0888F60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4BA255-8685-4868-802D-B0E510A8F89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60280" y="639720"/>
            <a:ext cx="6416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5: Detailed data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Saccharomyces  cerevisiae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22kb CLIP-PE libraries made by enzyme cutting and random shear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65240" y="1428840"/>
          <a:ext cx="6546600" cy="3693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5240" y="1428840"/>
                    <a:ext cx="6546600" cy="3693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8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2T17:03:19Z</dcterms:created>
  <dc:creator>jzhao</dc:creator>
  <dc:description/>
  <dc:language>en-US</dc:language>
  <cp:lastModifiedBy>jzhao</cp:lastModifiedBy>
  <dcterms:modified xsi:type="dcterms:W3CDTF">2011-12-05T20:56:07Z</dcterms:modified>
  <cp:revision>244</cp:revision>
  <dc:subject/>
  <dc:title>Slide 1</dc:title>
</cp:coreProperties>
</file>